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8DAE5-B45B-4D9E-A809-83E14AF92E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AE3BD-CE23-4F0A-9FB6-11B910D376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E8267-92F6-4558-99C9-1E0ECA1AE2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194B6-80BB-4242-9383-BCA43DC2F5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02732-D59D-4907-A92D-6E834AEDCD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06883E-694C-4C71-A921-F3AE7BA4F0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97CD1-5B49-4440-909F-4FB46C07F2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E4889C-01DF-4820-93D4-ADA374256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0B51C-8B64-442F-8BF6-9803411FD0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B12B2-E7FC-4E9D-8C3D-2244F6F71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D9BB9-46B2-47F4-B014-DA59A9105C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F6202-B749-42FE-A1C8-E6B4DB2CCA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EA70CA9-62CE-4F91-8269-64D41006D9D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4160" y="838080"/>
            <a:ext cx="8499240" cy="4339080"/>
            <a:chOff x="254160" y="838080"/>
            <a:chExt cx="8499240" cy="4339080"/>
          </a:xfrm>
        </p:grpSpPr>
        <p:grpSp>
          <p:nvGrpSpPr>
            <p:cNvPr id="42" name=""/>
            <p:cNvGrpSpPr/>
            <p:nvPr/>
          </p:nvGrpSpPr>
          <p:grpSpPr>
            <a:xfrm>
              <a:off x="295200" y="1273320"/>
              <a:ext cx="8453520" cy="1387440"/>
              <a:chOff x="295200" y="1273320"/>
              <a:chExt cx="8453520" cy="1387440"/>
            </a:xfrm>
          </p:grpSpPr>
          <p:sp>
            <p:nvSpPr>
              <p:cNvPr id="43" name=""/>
              <p:cNvSpPr/>
              <p:nvPr/>
            </p:nvSpPr>
            <p:spPr>
              <a:xfrm>
                <a:off x="363240" y="12859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398160" y="12859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56492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59984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3349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36988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94444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9793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484800" y="143820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24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360600" y="1619280"/>
                <a:ext cx="424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ou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782520" y="16192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1619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19868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77180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8081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516384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51987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59907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02568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660060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63552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7142400" y="1438200"/>
                <a:ext cx="21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48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7016400" y="1619280"/>
                <a:ext cx="424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ou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7440120" y="16192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781956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785448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842940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8464320" y="1655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95200" y="1273320"/>
                <a:ext cx="8208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116000" y="1273320"/>
                <a:ext cx="46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120680" y="1273320"/>
                <a:ext cx="9223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04300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04948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652840" y="127332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65896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326232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3268800" y="127332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87180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387828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481640" y="127332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48776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09112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097600" y="127332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70060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70708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310440" y="127332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631656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691992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6926400" y="127332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7529400" y="127332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753588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8139240" y="127332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8145360" y="127332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61800" y="1927080"/>
                <a:ext cx="957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C treatmen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320480" y="192708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19060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51424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80044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12372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40992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73356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029120" y="180504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L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287600" y="180504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089600" y="1955880"/>
                <a:ext cx="18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427320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638960" y="180504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L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897080" y="180504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655160" y="1955880"/>
                <a:ext cx="275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B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92732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5163840" y="19620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5198760" y="19620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584820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617184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645804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678132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7067520" y="1955880"/>
                <a:ext cx="323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CD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739116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7686720" y="180504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L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7945200" y="180504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7747200" y="1955880"/>
                <a:ext cx="183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D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792936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8296560" y="1805040"/>
                <a:ext cx="26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L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8554680" y="180504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8310960" y="1955880"/>
                <a:ext cx="275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B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8584920" y="19558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95200" y="1800360"/>
                <a:ext cx="8208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116000" y="1800360"/>
                <a:ext cx="46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1120680" y="1800360"/>
                <a:ext cx="9223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04300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04948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652840" y="180036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65896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26232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268800" y="180036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87180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87828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481640" y="180036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48776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09112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5097600" y="180036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570060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70708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6310440" y="180036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631656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691992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6926400" y="1800360"/>
                <a:ext cx="60300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7529400" y="1800360"/>
                <a:ext cx="648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753588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8139240" y="1800360"/>
                <a:ext cx="612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8145360" y="1800360"/>
                <a:ext cx="603360" cy="6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63240" y="21384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406080" y="2138400"/>
                <a:ext cx="4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1188720" y="21747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35224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96208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57156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18104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479088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5163840" y="21747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600984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661968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722916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783864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8448480" y="21686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95200" y="2108160"/>
                <a:ext cx="8222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117440" y="2108160"/>
                <a:ext cx="50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1122480" y="2108160"/>
                <a:ext cx="9205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04300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04948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652840" y="210816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65896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326232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3268800" y="210816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387180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87828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4481640" y="210816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448776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509112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5097600" y="210816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570060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570708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6310440" y="210816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631656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691992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6926400" y="210816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7529400" y="210816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753588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8139240" y="210816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8145360" y="210816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117440" y="2114640"/>
                <a:ext cx="5040" cy="2062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36324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3981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189440" y="2341440"/>
                <a:ext cx="64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MSO onl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8363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37744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25887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298692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6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319860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3666600" y="23414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380808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136400" y="23414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36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4175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81572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7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02740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16384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603504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1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62463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664452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1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685620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7324200" y="23414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746568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786384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8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807516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8473320" y="234144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8685000" y="234144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117440" y="2320920"/>
                <a:ext cx="5040" cy="166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36324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39816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189440" y="2508120"/>
                <a:ext cx="610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edia onl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80144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237744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5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258876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298692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5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319860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3666600" y="25081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380808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136400" y="250812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3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41756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481572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7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502740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516384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603504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624636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664452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685620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7324200" y="25081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746568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786384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9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807516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8473320" y="25081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"/>
            <p:cNvGrpSpPr/>
            <p:nvPr/>
          </p:nvGrpSpPr>
          <p:grpSpPr>
            <a:xfrm>
              <a:off x="295200" y="2487600"/>
              <a:ext cx="8453520" cy="1481400"/>
              <a:chOff x="295200" y="2487600"/>
              <a:chExt cx="8453520" cy="1481400"/>
            </a:xfrm>
          </p:grpSpPr>
          <p:sp>
            <p:nvSpPr>
              <p:cNvPr id="244" name=""/>
              <p:cNvSpPr/>
              <p:nvPr/>
            </p:nvSpPr>
            <p:spPr>
              <a:xfrm>
                <a:off x="8685000" y="2508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1117440" y="2487600"/>
                <a:ext cx="5040" cy="166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363600" y="2652840"/>
                <a:ext cx="92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455400" y="2652840"/>
                <a:ext cx="43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497880" y="26528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48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362880" y="2803680"/>
                <a:ext cx="3315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lon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694800" y="28036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1802880" y="28098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197784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237744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258876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298692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319860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3666600" y="2809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380808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4136400" y="28098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37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441756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481572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502740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516384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603504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4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624636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664452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4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685620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7324200" y="2809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746568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7863840" y="28098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92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807516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8543520" y="2809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9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8685000" y="28098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1117440" y="2654280"/>
                <a:ext cx="5040" cy="301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36324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39816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1802880" y="2976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197784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237744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5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258876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298692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5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319860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3666600" y="29764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380808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4136400" y="2976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56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441756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481572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5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502740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516384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603504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624636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664452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685620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7324200" y="29764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746568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7794000" y="2976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0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807516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8473320" y="297648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8685000" y="297648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117440" y="2955960"/>
                <a:ext cx="5040" cy="1652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36324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39816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1907640" y="31417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197784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237744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4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258876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298692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4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319860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3666600" y="3141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380808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4136400" y="314172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8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441756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481572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502740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516384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603504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3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624636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664452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3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685620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7324200" y="3141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746568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7794000" y="314172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0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807516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8473320" y="314172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8685000" y="31417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1117440" y="3121200"/>
                <a:ext cx="5040" cy="166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36324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39816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1907640" y="33084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197784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237744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4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258876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298692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4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319860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3666600" y="3308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380808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4136400" y="33084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77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441756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481572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8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502740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516384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603504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624636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664452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685620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7324200" y="3308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746568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7794000" y="330840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9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807516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8473320" y="3308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8685000" y="330840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1117440" y="3287880"/>
                <a:ext cx="5040" cy="16812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3632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3981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118872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12236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211572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21506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27255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276048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33350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33699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394452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39794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45543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458928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51638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51987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577332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58082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63831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641808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69926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70275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760212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763704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821196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8246880" y="34765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1117440" y="3456000"/>
                <a:ext cx="5040" cy="166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36324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39816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118872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211572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272556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333504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394452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455436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516384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577332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638316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699264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760212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8211960" y="365112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295200" y="3622680"/>
                <a:ext cx="8222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1117440" y="3622680"/>
                <a:ext cx="504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1122480" y="3622680"/>
                <a:ext cx="9205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204300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204948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2652840" y="362268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265896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326232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3268800" y="362268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387180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387828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4481640" y="362268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448776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509112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5097600" y="362268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570060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570708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6310440" y="362268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631656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691992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6926400" y="3622680"/>
                <a:ext cx="60300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7529400" y="3622680"/>
                <a:ext cx="648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753588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8139240" y="3622680"/>
                <a:ext cx="612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8145360" y="3622680"/>
                <a:ext cx="603360" cy="64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1117440" y="3629160"/>
                <a:ext cx="5040" cy="16668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36324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3981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1189440" y="3816360"/>
                <a:ext cx="64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MSO only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18363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2377440" y="38163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9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25887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2986920" y="38163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9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319860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3666600" y="38163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380808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4136400" y="3816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4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44175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4815720" y="38163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6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502740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516384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6035400" y="38163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6105240" y="38163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62463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6644520" y="38163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1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685620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7324200" y="38163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746568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7863840" y="381636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81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8075160" y="3816360"/>
                <a:ext cx="3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44" name=""/>
            <p:cNvSpPr/>
            <p:nvPr/>
          </p:nvSpPr>
          <p:spPr>
            <a:xfrm>
              <a:off x="8543520" y="3816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8685000" y="381636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1117440" y="3795840"/>
              <a:ext cx="5040" cy="164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36324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39816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189440" y="3981600"/>
              <a:ext cx="61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dia onl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180144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2377440" y="3981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258876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2986920" y="3981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319860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3666600" y="3981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380808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4136400" y="39816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0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441756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4815720" y="3981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502740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516384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6035040" y="39816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624636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6784560" y="3981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685620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7394040" y="3981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746568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8003880" y="3981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807516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8613360" y="39816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8685000" y="39816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1117440" y="3960720"/>
              <a:ext cx="5040" cy="168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363600" y="4143240"/>
              <a:ext cx="92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455400" y="4143240"/>
              <a:ext cx="4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498600" y="4143240"/>
              <a:ext cx="31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48 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817200" y="414324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802880" y="414972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197784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237744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258876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298692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319860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3666600" y="4149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380808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4136400" y="41497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441756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481572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502740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516384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603504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624636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664452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685620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7324200" y="41497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746568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786384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807516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8473320" y="4149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8685000" y="41497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1117440" y="4129200"/>
              <a:ext cx="5040" cy="166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363600" y="435132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595080" y="4351320"/>
              <a:ext cx="4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637920" y="4351320"/>
              <a:ext cx="26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hC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904680" y="4341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977400" y="43513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1802880" y="43560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197784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237744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258876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298692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319860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3666600" y="4356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80808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4136400" y="43560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441756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481572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502740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516384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603504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624636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664452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685620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7324200" y="4356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746568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7863840" y="4356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807516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8543520" y="4356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8685000" y="43560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1117440" y="4295880"/>
              <a:ext cx="5040" cy="206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36324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39816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1907640" y="4522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197784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2377440" y="45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258876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2986920" y="45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319860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3666600" y="4522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380808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136400" y="45226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64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441756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4815720" y="45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502740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516384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6035040" y="45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624636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6644520" y="452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685620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7324200" y="4522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746568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7794000" y="45226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1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807516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8543520" y="4522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8685000" y="452268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1117440" y="4502160"/>
              <a:ext cx="5040" cy="165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36324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39816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190764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197784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237744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258876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298692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319860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3666600" y="46879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380808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4136400" y="46879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8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441756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481572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502740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516384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603504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624636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664452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685620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7324200" y="46879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746568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7794000" y="46879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3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807516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8473320" y="4687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8685000" y="468792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1117440" y="4667400"/>
              <a:ext cx="5040" cy="168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3632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981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18872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12236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211572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21506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27255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276048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33350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33699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394452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39794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45543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458928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51638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51987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577332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58082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63831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641808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69926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70275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760212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763704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821196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8246880" y="4840200"/>
              <a:ext cx="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285840" y="4986360"/>
              <a:ext cx="83160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1117440" y="4835520"/>
              <a:ext cx="5040" cy="150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1117440" y="4986360"/>
              <a:ext cx="504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1122480" y="4986360"/>
              <a:ext cx="92556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203832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204480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264780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265428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3257640" y="4986360"/>
              <a:ext cx="61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3263760" y="4986360"/>
              <a:ext cx="6130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386712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387360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447660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448308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5086440" y="4986360"/>
              <a:ext cx="61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5092560" y="4986360"/>
              <a:ext cx="6130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569592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570240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630540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631188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6915240" y="4986360"/>
              <a:ext cx="61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6921360" y="4986360"/>
              <a:ext cx="6130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752472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753120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8134200" y="4986360"/>
              <a:ext cx="648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8140680" y="4986360"/>
              <a:ext cx="612720" cy="6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304560" y="4994280"/>
              <a:ext cx="38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5" name=""/>
            <p:cNvGrpSpPr/>
            <p:nvPr/>
          </p:nvGrpSpPr>
          <p:grpSpPr>
            <a:xfrm>
              <a:off x="689400" y="838080"/>
              <a:ext cx="7323120" cy="182880"/>
              <a:chOff x="689400" y="838080"/>
              <a:chExt cx="7323120" cy="182880"/>
            </a:xfrm>
          </p:grpSpPr>
          <p:sp>
            <p:nvSpPr>
              <p:cNvPr id="636" name=""/>
              <p:cNvSpPr/>
              <p:nvPr/>
            </p:nvSpPr>
            <p:spPr>
              <a:xfrm>
                <a:off x="689400" y="838080"/>
                <a:ext cx="4197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              </a:t>
                </a: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Phenotyping of DC surface markers following exposure to v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4888080" y="838080"/>
                <a:ext cx="2809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accine in combination with TLR 7/8 agonist 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7696080" y="838080"/>
                <a:ext cx="51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7745040" y="838080"/>
                <a:ext cx="229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84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7973640" y="838080"/>
                <a:ext cx="38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1" name=""/>
            <p:cNvSpPr/>
            <p:nvPr/>
          </p:nvSpPr>
          <p:spPr>
            <a:xfrm>
              <a:off x="254160" y="1295280"/>
              <a:ext cx="8458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304920" y="3581280"/>
              <a:ext cx="8381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5410080" y="1295280"/>
              <a:ext cx="0" cy="365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4T21:26:09Z</dcterms:created>
  <dc:creator> </dc:creator>
  <dc:description/>
  <dc:language>en-US</dc:language>
  <cp:lastModifiedBy> </cp:lastModifiedBy>
  <dcterms:modified xsi:type="dcterms:W3CDTF">2007-01-19T19:10:58Z</dcterms:modified>
  <cp:revision>51</cp:revision>
  <dc:subject/>
  <dc:title>Slide 1</dc:title>
</cp:coreProperties>
</file>